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318" r:id="rId2"/>
    <p:sldId id="332" r:id="rId3"/>
    <p:sldId id="316" r:id="rId4"/>
    <p:sldId id="293" r:id="rId5"/>
    <p:sldId id="262" r:id="rId6"/>
    <p:sldId id="311" r:id="rId7"/>
    <p:sldId id="312" r:id="rId8"/>
    <p:sldId id="315" r:id="rId9"/>
    <p:sldId id="317" r:id="rId10"/>
    <p:sldId id="331" r:id="rId11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539" autoAdjust="0"/>
    <p:restoredTop sz="94660"/>
  </p:normalViewPr>
  <p:slideViewPr>
    <p:cSldViewPr>
      <p:cViewPr>
        <p:scale>
          <a:sx n="66" d="100"/>
          <a:sy n="66" d="100"/>
        </p:scale>
        <p:origin x="-2074" y="-42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181823-C063-419C-8A0D-1EF35C31E5C3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602335-857B-417C-9C99-D73D989B99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4167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41433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2089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4735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6281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1594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9488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633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850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8854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587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0239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0805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2B747-BF60-42E5-93D5-A9C10A0E8CC6}" type="datetimeFigureOut">
              <a:rPr lang="ko-KR" altLang="en-US" smtClean="0"/>
              <a:t>2022-1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6099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23" y="3717032"/>
            <a:ext cx="3657025" cy="31166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직사각형 3"/>
          <p:cNvSpPr/>
          <p:nvPr/>
        </p:nvSpPr>
        <p:spPr>
          <a:xfrm>
            <a:off x="7380312" y="-962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8456" y="3941574"/>
            <a:ext cx="3615872" cy="268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직사각형 7"/>
          <p:cNvSpPr/>
          <p:nvPr/>
        </p:nvSpPr>
        <p:spPr>
          <a:xfrm>
            <a:off x="3808713" y="6623774"/>
            <a:ext cx="207460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*</a:t>
            </a:r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Exdom</a:t>
            </a:r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: </a:t>
            </a:r>
            <a:r>
              <a:rPr lang="en-US" altLang="ko-KR" sz="1100" dirty="0">
                <a:latin typeface="Arial" pitchFamily="34" charset="0"/>
                <a:cs typeface="Arial" pitchFamily="34" charset="0"/>
              </a:rPr>
              <a:t>Extracellular domain</a:t>
            </a:r>
            <a:endParaRPr lang="ko-KR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오른쪽 화살표 4"/>
          <p:cNvSpPr/>
          <p:nvPr/>
        </p:nvSpPr>
        <p:spPr>
          <a:xfrm>
            <a:off x="3275856" y="1097360"/>
            <a:ext cx="1512168" cy="108012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Efficient Screening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0" name="Picture 6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0742" y="264913"/>
            <a:ext cx="4248000" cy="26326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직사각형 8"/>
          <p:cNvSpPr/>
          <p:nvPr/>
        </p:nvSpPr>
        <p:spPr>
          <a:xfrm>
            <a:off x="6588224" y="3212976"/>
            <a:ext cx="1440160" cy="360040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Candidate 13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아래쪽 화살표 6"/>
          <p:cNvSpPr/>
          <p:nvPr/>
        </p:nvSpPr>
        <p:spPr>
          <a:xfrm>
            <a:off x="6977516" y="2708920"/>
            <a:ext cx="661576" cy="36004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5" name="아래쪽 화살표 14"/>
          <p:cNvSpPr/>
          <p:nvPr/>
        </p:nvSpPr>
        <p:spPr>
          <a:xfrm rot="1956075">
            <a:off x="6585464" y="3766750"/>
            <a:ext cx="661576" cy="36004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7" name="아래쪽 화살표 16"/>
          <p:cNvSpPr/>
          <p:nvPr/>
        </p:nvSpPr>
        <p:spPr>
          <a:xfrm rot="5400000">
            <a:off x="3557136" y="4801902"/>
            <a:ext cx="661576" cy="36004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pic>
        <p:nvPicPr>
          <p:cNvPr id="1031" name="Picture 7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24" y="224976"/>
            <a:ext cx="3060000" cy="30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6124236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 preferRelativeResize="0"/>
          <p:nvPr/>
        </p:nvPicPr>
        <p:blipFill>
          <a:blip r:embed="rId2"/>
          <a:stretch>
            <a:fillRect/>
          </a:stretch>
        </p:blipFill>
        <p:spPr>
          <a:xfrm>
            <a:off x="65540" y="2420888"/>
            <a:ext cx="7740000" cy="2520280"/>
          </a:xfrm>
          <a:prstGeom prst="rect">
            <a:avLst/>
          </a:prstGeom>
        </p:spPr>
      </p:pic>
      <p:sp>
        <p:nvSpPr>
          <p:cNvPr id="12" name="직사각형 11"/>
          <p:cNvSpPr/>
          <p:nvPr/>
        </p:nvSpPr>
        <p:spPr>
          <a:xfrm>
            <a:off x="-74442" y="-2738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-74442" y="2348880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7380312" y="0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/>
          <p:cNvPicPr preferRelativeResize="0"/>
          <p:nvPr/>
        </p:nvPicPr>
        <p:blipFill>
          <a:blip r:embed="rId3"/>
          <a:stretch>
            <a:fillRect/>
          </a:stretch>
        </p:blipFill>
        <p:spPr>
          <a:xfrm>
            <a:off x="65540" y="311170"/>
            <a:ext cx="5400000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0208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021" y="4500375"/>
            <a:ext cx="306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9912" y="4546800"/>
            <a:ext cx="306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직사각형 7"/>
          <p:cNvSpPr/>
          <p:nvPr/>
        </p:nvSpPr>
        <p:spPr>
          <a:xfrm>
            <a:off x="7380312" y="-962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021" y="146477"/>
            <a:ext cx="288000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9912" y="146477"/>
            <a:ext cx="288000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-74442" y="-2738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3491880" y="-2738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42002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7344816" y="0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41605"/>
            <a:ext cx="5230048" cy="34053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-74442" y="-2738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-74442" y="184482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4123818"/>
            <a:ext cx="5230048" cy="23295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직사각형 7"/>
          <p:cNvSpPr/>
          <p:nvPr/>
        </p:nvSpPr>
        <p:spPr>
          <a:xfrm>
            <a:off x="-74442" y="3954542"/>
            <a:ext cx="3321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34497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5" name="Picture 3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3480" y="1031250"/>
            <a:ext cx="3960000" cy="28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-108520" y="1175266"/>
            <a:ext cx="115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-108520" y="2543418"/>
            <a:ext cx="115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2DG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-108520" y="2903458"/>
            <a:ext cx="115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2DG+Caloxin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-108520" y="3191490"/>
            <a:ext cx="115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2DG+C13</a:t>
            </a:r>
          </a:p>
        </p:txBody>
      </p:sp>
      <p:sp>
        <p:nvSpPr>
          <p:cNvPr id="14" name="직사각형 13"/>
          <p:cNvSpPr/>
          <p:nvPr/>
        </p:nvSpPr>
        <p:spPr>
          <a:xfrm>
            <a:off x="2761229" y="671210"/>
            <a:ext cx="524503" cy="276999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s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231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직사각형 14"/>
          <p:cNvSpPr/>
          <p:nvPr/>
        </p:nvSpPr>
        <p:spPr>
          <a:xfrm>
            <a:off x="6784060" y="671210"/>
            <a:ext cx="688009" cy="276999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MCF7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-108520" y="1679322"/>
            <a:ext cx="115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Calox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-108520" y="2137792"/>
            <a:ext cx="115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Candidate13</a:t>
            </a:r>
          </a:p>
        </p:txBody>
      </p:sp>
      <p:pic>
        <p:nvPicPr>
          <p:cNvPr id="18442" name="Picture 10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8064" y="1031250"/>
            <a:ext cx="3960000" cy="28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직사각형 17"/>
          <p:cNvSpPr/>
          <p:nvPr/>
        </p:nvSpPr>
        <p:spPr>
          <a:xfrm>
            <a:off x="7308304" y="-962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직사각형 18"/>
          <p:cNvSpPr/>
          <p:nvPr/>
        </p:nvSpPr>
        <p:spPr>
          <a:xfrm>
            <a:off x="-36512" y="620688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직사각형 19"/>
          <p:cNvSpPr/>
          <p:nvPr/>
        </p:nvSpPr>
        <p:spPr>
          <a:xfrm>
            <a:off x="4932040" y="620688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-36512" y="-27384"/>
            <a:ext cx="223224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Supplementary Figures</a:t>
            </a:r>
            <a:endParaRPr lang="ko-KR" altLang="ko-KR" sz="1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53126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480" y="1419122"/>
            <a:ext cx="3600000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7293" y="1419122"/>
            <a:ext cx="2661171" cy="4436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직사각형 3"/>
          <p:cNvSpPr/>
          <p:nvPr/>
        </p:nvSpPr>
        <p:spPr>
          <a:xfrm>
            <a:off x="1907584" y="887234"/>
            <a:ext cx="1584176" cy="429925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dirty="0" smtClean="0"/>
              <a:t>YUMC-C1</a:t>
            </a:r>
            <a:endParaRPr lang="ko-KR" altLang="en-US" dirty="0"/>
          </a:p>
        </p:txBody>
      </p:sp>
      <p:sp>
        <p:nvSpPr>
          <p:cNvPr id="5" name="직사각형 4"/>
          <p:cNvSpPr/>
          <p:nvPr/>
        </p:nvSpPr>
        <p:spPr>
          <a:xfrm>
            <a:off x="6519341" y="887234"/>
            <a:ext cx="1584176" cy="429925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dirty="0" smtClean="0"/>
              <a:t>YUMC-C2</a:t>
            </a:r>
            <a:endParaRPr lang="ko-KR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-108520" y="1535306"/>
            <a:ext cx="108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-108520" y="3335506"/>
            <a:ext cx="108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Oxaliplat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108520" y="3768715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Oxaliplat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Calox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108520" y="4272771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Oxaliplat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+C1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-108520" y="2111370"/>
            <a:ext cx="108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Calox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-108520" y="2687434"/>
            <a:ext cx="108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Candidate13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004168" y="1535306"/>
            <a:ext cx="108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004168" y="3937992"/>
            <a:ext cx="108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Oxaliplat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004168" y="4632811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Oxaliplat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Calox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04168" y="5352891"/>
            <a:ext cx="1080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Oxaliplat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+C13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004168" y="2353816"/>
            <a:ext cx="108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Calox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004168" y="3145904"/>
            <a:ext cx="108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Candidate13</a:t>
            </a:r>
          </a:p>
        </p:txBody>
      </p:sp>
      <p:sp>
        <p:nvSpPr>
          <p:cNvPr id="19" name="직사각형 18"/>
          <p:cNvSpPr/>
          <p:nvPr/>
        </p:nvSpPr>
        <p:spPr>
          <a:xfrm>
            <a:off x="-36512" y="620688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직사각형 19"/>
          <p:cNvSpPr/>
          <p:nvPr/>
        </p:nvSpPr>
        <p:spPr>
          <a:xfrm>
            <a:off x="5043166" y="620688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직사각형 20"/>
          <p:cNvSpPr/>
          <p:nvPr/>
        </p:nvSpPr>
        <p:spPr>
          <a:xfrm>
            <a:off x="7308304" y="0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42292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0072" y="1253151"/>
            <a:ext cx="3600000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9512" y="1386311"/>
            <a:ext cx="144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79512" y="1943254"/>
            <a:ext cx="144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Sorafenib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79512" y="3573016"/>
            <a:ext cx="144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Sorafenib+Calox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79512" y="4005064"/>
            <a:ext cx="144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Sorafenib+C13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79512" y="2447310"/>
            <a:ext cx="144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err="1" smtClean="0">
                <a:latin typeface="Arial" pitchFamily="34" charset="0"/>
                <a:cs typeface="Arial" pitchFamily="34" charset="0"/>
              </a:rPr>
              <a:t>Caloxin</a:t>
            </a:r>
            <a:endParaRPr lang="en-US" altLang="ko-KR" sz="11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9512" y="3023374"/>
            <a:ext cx="144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 smtClean="0">
                <a:latin typeface="Arial" pitchFamily="34" charset="0"/>
                <a:cs typeface="Arial" pitchFamily="34" charset="0"/>
              </a:rPr>
              <a:t>Candidate13</a:t>
            </a:r>
          </a:p>
        </p:txBody>
      </p:sp>
      <p:sp>
        <p:nvSpPr>
          <p:cNvPr id="15" name="직사각형 14"/>
          <p:cNvSpPr/>
          <p:nvPr/>
        </p:nvSpPr>
        <p:spPr>
          <a:xfrm>
            <a:off x="2196136" y="694819"/>
            <a:ext cx="1584176" cy="429925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dirty="0" smtClean="0"/>
              <a:t>YUMC-P1</a:t>
            </a:r>
            <a:endParaRPr lang="ko-KR" altLang="en-US" dirty="0"/>
          </a:p>
        </p:txBody>
      </p:sp>
      <p:sp>
        <p:nvSpPr>
          <p:cNvPr id="17" name="직사각형 16"/>
          <p:cNvSpPr/>
          <p:nvPr/>
        </p:nvSpPr>
        <p:spPr>
          <a:xfrm>
            <a:off x="107504" y="620688"/>
            <a:ext cx="3321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7308304" y="0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56185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26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503" y="656992"/>
            <a:ext cx="8280000" cy="27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503" y="4077072"/>
            <a:ext cx="8280000" cy="27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3959951" y="44624"/>
            <a:ext cx="1152128" cy="36000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dirty="0" smtClean="0"/>
              <a:t>S231</a:t>
            </a:r>
            <a:endParaRPr lang="ko-KR" altLang="en-US" dirty="0"/>
          </a:p>
        </p:txBody>
      </p:sp>
      <p:sp>
        <p:nvSpPr>
          <p:cNvPr id="10" name="직사각형 9"/>
          <p:cNvSpPr/>
          <p:nvPr/>
        </p:nvSpPr>
        <p:spPr>
          <a:xfrm>
            <a:off x="3960392" y="3573056"/>
            <a:ext cx="1152128" cy="360000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dirty="0" smtClean="0"/>
              <a:t>S-MCF-7</a:t>
            </a:r>
            <a:endParaRPr lang="ko-KR" altLang="en-US" dirty="0"/>
          </a:p>
        </p:txBody>
      </p:sp>
      <p:sp>
        <p:nvSpPr>
          <p:cNvPr id="9" name="직사각형 8"/>
          <p:cNvSpPr/>
          <p:nvPr/>
        </p:nvSpPr>
        <p:spPr>
          <a:xfrm>
            <a:off x="7308304" y="0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35496" y="45890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4460874" y="45890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35496" y="4026550"/>
            <a:ext cx="3321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직사각형 18"/>
          <p:cNvSpPr/>
          <p:nvPr/>
        </p:nvSpPr>
        <p:spPr>
          <a:xfrm>
            <a:off x="4460874" y="4026550"/>
            <a:ext cx="3321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17553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000" y="476250"/>
            <a:ext cx="4320000" cy="28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4075" y="476250"/>
            <a:ext cx="4320000" cy="28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4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1950" y="3959225"/>
            <a:ext cx="4320000" cy="28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직사각형 10"/>
          <p:cNvSpPr/>
          <p:nvPr/>
        </p:nvSpPr>
        <p:spPr>
          <a:xfrm>
            <a:off x="1512408" y="44624"/>
            <a:ext cx="1584176" cy="429925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dirty="0" smtClean="0"/>
              <a:t>YUMC-C1</a:t>
            </a:r>
            <a:endParaRPr lang="ko-KR" altLang="en-US" dirty="0"/>
          </a:p>
        </p:txBody>
      </p:sp>
      <p:sp>
        <p:nvSpPr>
          <p:cNvPr id="12" name="직사각형 11"/>
          <p:cNvSpPr/>
          <p:nvPr/>
        </p:nvSpPr>
        <p:spPr>
          <a:xfrm>
            <a:off x="6012400" y="44624"/>
            <a:ext cx="1584176" cy="429925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dirty="0" smtClean="0"/>
              <a:t>YUMC-C2</a:t>
            </a:r>
            <a:endParaRPr lang="ko-KR" altLang="en-US" dirty="0"/>
          </a:p>
        </p:txBody>
      </p:sp>
      <p:sp>
        <p:nvSpPr>
          <p:cNvPr id="13" name="직사각형 12"/>
          <p:cNvSpPr/>
          <p:nvPr/>
        </p:nvSpPr>
        <p:spPr>
          <a:xfrm>
            <a:off x="3779118" y="3501008"/>
            <a:ext cx="1584176" cy="429925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dirty="0" smtClean="0"/>
              <a:t>YUMC-P1</a:t>
            </a:r>
            <a:endParaRPr lang="ko-KR" altLang="en-US" dirty="0"/>
          </a:p>
        </p:txBody>
      </p:sp>
      <p:sp>
        <p:nvSpPr>
          <p:cNvPr id="8" name="직사각형 7"/>
          <p:cNvSpPr/>
          <p:nvPr/>
        </p:nvSpPr>
        <p:spPr>
          <a:xfrm>
            <a:off x="-36512" y="-2738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4388866" y="-2738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2151626" y="3501008"/>
            <a:ext cx="3321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7416824" y="0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39362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381" y="189120"/>
            <a:ext cx="2952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직사각형 11"/>
          <p:cNvSpPr/>
          <p:nvPr/>
        </p:nvSpPr>
        <p:spPr>
          <a:xfrm>
            <a:off x="-74442" y="-2738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3700877" y="-2738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9911" y="188640"/>
            <a:ext cx="3312369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직사각형 9"/>
          <p:cNvSpPr/>
          <p:nvPr/>
        </p:nvSpPr>
        <p:spPr>
          <a:xfrm>
            <a:off x="7380312" y="0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1532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5</TotalTime>
  <Words>105</Words>
  <Application>Microsoft Office PowerPoint</Application>
  <PresentationFormat>화면 슬라이드 쇼(4:3)</PresentationFormat>
  <Paragraphs>74</Paragraphs>
  <Slides>10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1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oshiba</dc:creator>
  <cp:lastModifiedBy>Windows 사용자</cp:lastModifiedBy>
  <cp:revision>70</cp:revision>
  <dcterms:created xsi:type="dcterms:W3CDTF">2015-06-17T04:40:12Z</dcterms:created>
  <dcterms:modified xsi:type="dcterms:W3CDTF">2022-12-13T04:19:26Z</dcterms:modified>
</cp:coreProperties>
</file>